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676F68-0D07-883A-358F-6969C15E10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1832A9-74C0-BFE8-A941-E5357D05DA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2F21A-FCDE-E772-A6B3-A3F6329A9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83603-AC0D-CC60-11A0-C95C3EF8E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2158F-8AB8-17FA-4DCD-1B1E9C25D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053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08409-6F99-9BB4-3B3B-D2282BE6F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8E0122-5D68-7A0F-D724-0B679CBD72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957CB2-1556-39FB-1E21-55E06C340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828B2F-CEFE-968D-034B-E814470FF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E063C-AEBC-3DEC-282C-17306246A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84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F5AB84-76EE-4CA9-AE6B-57615268D8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D4B052-9129-9D2C-82F5-71F3E0CD4B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CCF3B-0AB6-5DAC-7638-BE0C6BE80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508A7E-0B58-6ED2-9588-FAC3FD330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9A34A-6232-9355-1919-593FAC7F9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611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3BCE0A-87F4-B342-7AFC-A3BDFF54C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BFDAFD-9FA5-2B02-565C-9950DB9249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873354-77AE-923D-40A2-A3C5E5675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9E6C6-CB10-56E5-913A-D358CB765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AD0FD9-CCD5-A6B3-5601-2D34297D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0112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83164-0B5D-D045-F4CA-6EB243067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2684FB-AB59-EE8F-6B62-0CC3B9CBC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6C160-E7EE-FEA7-F274-A5F949469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95853B-D85A-BE2D-051C-5C0212605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45DE2C-6003-BF7B-3B1A-AE412DD1E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2894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ADE3F-6230-94B6-790E-DCC82D528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AAE29F-0845-3BE6-6720-B763891446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A2E487-BF20-241B-97B3-F77D0DAC2C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B4E6A1-1560-EEEC-D449-96BD7B86D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137C80-A6AB-E08B-2926-3092A19D5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14A5A1-4554-0E55-ABFE-96070324C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299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CD0D08-6EAD-6C43-4980-595ADDBD5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4510D8-23B4-C03C-3900-EE341E1C60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811C64-1A6E-7F2A-32F6-1F3B8DF253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7DB517-FC52-E3F1-DDD1-950F22D12A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5AB4F3-D734-C7C6-5BF6-FF7466876C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066F97-A037-B2C8-93CD-79E63BE49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8403AE-0E51-4011-466F-B8C7C4E3C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50573F-BB06-5290-6EA6-52E82ED33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953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CF0066-E5A8-6DDD-8959-04D2E6FC1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68AC1B-0F1B-60DD-1142-CE6C9D170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17CA0C-FC40-AA7B-2881-95DF2C937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E550DE-1F89-F057-1A11-48156E27F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5572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50AD5F-219C-63E8-F6D0-0D4B3E0CA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90D407-45C4-81B9-46B8-5517626AB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8302E3-1303-D4EF-6D9D-16691CF41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52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E981A-4D16-DEF7-72BB-5DC94F8E1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366D2-4E78-C75E-F09A-592BCF161D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6E5CB8-F00F-F9D7-F3EF-AF2B854A22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EDD094-CA7E-1191-FC07-C45157DF6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091762-ACE6-FBB0-9446-358E40D5C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0244F5-37DD-90C2-FD9E-8774206E6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511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A0C8D-6C29-3E29-B2D8-E8A059CFB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0339A1-B6EB-25ED-A6C2-917366D0C8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DCA4B8-3B67-EC61-FC2F-2615E79E95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841E56-3A31-C18F-100A-A5729DE98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B3A89E-7F44-9AE5-E0F9-0A4E12A78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6DD8A7-564A-7602-D4F0-76F66CA00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447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718C35-56CA-0E3B-447A-DB529CCF9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DA8EE2-10C0-9D57-A918-84D3F997D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2B6FF5-EA7E-D649-443D-8FC7A1B8EF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95A86B-1965-4070-8497-7DB6128D3E1B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77C617-6073-DF09-0D8B-84E7B75887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B08E1-0BD8-08AF-061E-84D5ECB945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5418C1-F97B-488D-9891-53AC49D5A9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782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and white image of a dna test&#10;&#10;Description automatically generated">
            <a:extLst>
              <a:ext uri="{FF2B5EF4-FFF2-40B4-BE49-F238E27FC236}">
                <a16:creationId xmlns:a16="http://schemas.microsoft.com/office/drawing/2014/main" id="{BB1452A6-28F3-D668-6818-DEB428B0D3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79" t="-1596" r="-771" b="-3476"/>
          <a:stretch/>
        </p:blipFill>
        <p:spPr>
          <a:xfrm>
            <a:off x="291830" y="384003"/>
            <a:ext cx="5107021" cy="3083667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E987414-F8E5-D5C3-5E54-051770A4A20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-651" t="-971" r="618" b="-236"/>
          <a:stretch/>
        </p:blipFill>
        <p:spPr>
          <a:xfrm>
            <a:off x="291830" y="3667328"/>
            <a:ext cx="5593403" cy="3083668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C56BC91-24EB-6CE7-099E-F8A93ADF9ED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53" t="-627" r="-84" b="246"/>
          <a:stretch/>
        </p:blipFill>
        <p:spPr>
          <a:xfrm>
            <a:off x="5885233" y="384003"/>
            <a:ext cx="5107021" cy="3083668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B4D466A-BFE5-080A-5F1A-255A2C3CCBBB}"/>
              </a:ext>
            </a:extLst>
          </p:cNvPr>
          <p:cNvSpPr txBox="1"/>
          <p:nvPr/>
        </p:nvSpPr>
        <p:spPr>
          <a:xfrm>
            <a:off x="8858" y="107004"/>
            <a:ext cx="2102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T29_biological replicate_n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FBC2CEE-FC57-49C3-E46C-7B1A0AC1FECE}"/>
              </a:ext>
            </a:extLst>
          </p:cNvPr>
          <p:cNvSpPr/>
          <p:nvPr/>
        </p:nvSpPr>
        <p:spPr>
          <a:xfrm>
            <a:off x="2744293" y="1731195"/>
            <a:ext cx="990363" cy="19520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16E762-94B3-2AA8-1D8B-BFA9B14383F8}"/>
              </a:ext>
            </a:extLst>
          </p:cNvPr>
          <p:cNvSpPr txBox="1"/>
          <p:nvPr/>
        </p:nvSpPr>
        <p:spPr>
          <a:xfrm>
            <a:off x="3734656" y="1690299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6B91573-A8A4-2995-EE1F-31EC0E995A98}"/>
              </a:ext>
            </a:extLst>
          </p:cNvPr>
          <p:cNvSpPr/>
          <p:nvPr/>
        </p:nvSpPr>
        <p:spPr>
          <a:xfrm>
            <a:off x="2664219" y="5496733"/>
            <a:ext cx="1706303" cy="20171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AB8A75-96EA-784B-4A05-2F105CF8C69D}"/>
              </a:ext>
            </a:extLst>
          </p:cNvPr>
          <p:cNvSpPr txBox="1"/>
          <p:nvPr/>
        </p:nvSpPr>
        <p:spPr>
          <a:xfrm>
            <a:off x="4370522" y="5421677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7153891-1CEE-4A5A-5789-F7C5E7A75947}"/>
              </a:ext>
            </a:extLst>
          </p:cNvPr>
          <p:cNvSpPr/>
          <p:nvPr/>
        </p:nvSpPr>
        <p:spPr>
          <a:xfrm>
            <a:off x="8095201" y="2157787"/>
            <a:ext cx="1646207" cy="20171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55B0B1-1755-0F50-2B44-70FEB72C2CD5}"/>
              </a:ext>
            </a:extLst>
          </p:cNvPr>
          <p:cNvSpPr txBox="1"/>
          <p:nvPr/>
        </p:nvSpPr>
        <p:spPr>
          <a:xfrm>
            <a:off x="9755829" y="2120142"/>
            <a:ext cx="611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ATG12</a:t>
            </a:r>
          </a:p>
        </p:txBody>
      </p:sp>
    </p:spTree>
    <p:extLst>
      <p:ext uri="{BB962C8B-B14F-4D97-AF65-F5344CB8AC3E}">
        <p14:creationId xmlns:p14="http://schemas.microsoft.com/office/powerpoint/2010/main" val="18673311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15ADF58-4233-FC4D-BDF5-E2EF4E174BD7}"/>
              </a:ext>
            </a:extLst>
          </p:cNvPr>
          <p:cNvSpPr txBox="1"/>
          <p:nvPr/>
        </p:nvSpPr>
        <p:spPr>
          <a:xfrm>
            <a:off x="8858" y="107004"/>
            <a:ext cx="2102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T29_biological replicate_n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76C129C-6AC7-18AE-5DCF-CF940A0C3CD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151" t="-970" r="-261" b="-1387"/>
          <a:stretch/>
        </p:blipFill>
        <p:spPr bwMode="auto">
          <a:xfrm>
            <a:off x="5966278" y="630486"/>
            <a:ext cx="5033225" cy="2798514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DDA579B-94BB-E0C5-A968-03EC5BD2598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-99" t="90" r="199" b="176"/>
          <a:stretch/>
        </p:blipFill>
        <p:spPr>
          <a:xfrm>
            <a:off x="490377" y="3646886"/>
            <a:ext cx="5033225" cy="3066841"/>
          </a:xfrm>
          <a:prstGeom prst="rect">
            <a:avLst/>
          </a:prstGeom>
          <a:ln>
            <a:noFill/>
          </a:ln>
        </p:spPr>
      </p:pic>
      <p:pic>
        <p:nvPicPr>
          <p:cNvPr id="8" name="Picture 7" descr="A close-up of a square&#10;&#10;Description automatically generated">
            <a:extLst>
              <a:ext uri="{FF2B5EF4-FFF2-40B4-BE49-F238E27FC236}">
                <a16:creationId xmlns:a16="http://schemas.microsoft.com/office/drawing/2014/main" id="{AA19369A-1026-3045-E371-E508EA5025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46" t="-543" r="49" b="-95"/>
          <a:stretch/>
        </p:blipFill>
        <p:spPr>
          <a:xfrm>
            <a:off x="308113" y="643090"/>
            <a:ext cx="5215489" cy="2920073"/>
          </a:xfrm>
          <a:prstGeom prst="rect">
            <a:avLst/>
          </a:prstGeom>
          <a:ln>
            <a:noFill/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92E3AB66-87DE-3FA2-1D3C-7B21A30B0470}"/>
              </a:ext>
            </a:extLst>
          </p:cNvPr>
          <p:cNvSpPr/>
          <p:nvPr/>
        </p:nvSpPr>
        <p:spPr>
          <a:xfrm>
            <a:off x="3022188" y="2042354"/>
            <a:ext cx="990363" cy="19520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877C84-2292-19B0-AF21-F91D1246D37E}"/>
              </a:ext>
            </a:extLst>
          </p:cNvPr>
          <p:cNvSpPr txBox="1"/>
          <p:nvPr/>
        </p:nvSpPr>
        <p:spPr>
          <a:xfrm>
            <a:off x="4011669" y="200145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DC63AEB-70B0-A6E0-BA9F-948E093C4ED0}"/>
              </a:ext>
            </a:extLst>
          </p:cNvPr>
          <p:cNvSpPr/>
          <p:nvPr/>
        </p:nvSpPr>
        <p:spPr>
          <a:xfrm>
            <a:off x="3022188" y="5041806"/>
            <a:ext cx="1599972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F445DB-1299-21DE-2E12-8F57FECE48DD}"/>
              </a:ext>
            </a:extLst>
          </p:cNvPr>
          <p:cNvSpPr txBox="1"/>
          <p:nvPr/>
        </p:nvSpPr>
        <p:spPr>
          <a:xfrm>
            <a:off x="4622160" y="504180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424FAD2-316B-85CC-CCD7-74A8B5D1F353}"/>
              </a:ext>
            </a:extLst>
          </p:cNvPr>
          <p:cNvSpPr/>
          <p:nvPr/>
        </p:nvSpPr>
        <p:spPr>
          <a:xfrm>
            <a:off x="8300053" y="1918432"/>
            <a:ext cx="1570458" cy="20171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3068B9-B9AA-E726-C538-9391C97A98D8}"/>
              </a:ext>
            </a:extLst>
          </p:cNvPr>
          <p:cNvSpPr txBox="1"/>
          <p:nvPr/>
        </p:nvSpPr>
        <p:spPr>
          <a:xfrm>
            <a:off x="9946259" y="1891243"/>
            <a:ext cx="611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ATG12</a:t>
            </a:r>
          </a:p>
        </p:txBody>
      </p:sp>
    </p:spTree>
    <p:extLst>
      <p:ext uri="{BB962C8B-B14F-4D97-AF65-F5344CB8AC3E}">
        <p14:creationId xmlns:p14="http://schemas.microsoft.com/office/powerpoint/2010/main" val="1185389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2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3</cp:revision>
  <dcterms:created xsi:type="dcterms:W3CDTF">2024-09-01T00:10:12Z</dcterms:created>
  <dcterms:modified xsi:type="dcterms:W3CDTF">2024-09-01T00:22:16Z</dcterms:modified>
</cp:coreProperties>
</file>